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6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624" y="108"/>
      </p:cViewPr>
      <p:guideLst>
        <p:guide orient="horz" pos="2160"/>
        <p:guide pos="36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5056CB-27CB-FF32-A6D8-76763A8B16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D8AB6CA-6E87-4299-D3D1-2058DFEEFF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40FFAF-808B-558D-22B8-E92A193DA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A408AD-D711-A0B5-81E9-78AF4C107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587A781-451D-4937-3B75-1EDCFC1C1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4458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A8490F-B158-F71E-6589-F218B5D376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409613D-6C75-610E-5C7A-724C0273F7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59FB739-095A-EC02-965C-560395C41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B025BB-5CF2-E99B-531F-98390796C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6D3773C-28F7-8996-5A92-DAEA34980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656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694A175-8172-C0E0-F2B6-8DE4BB653A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7319250-EEA0-0C26-4D70-3E8FC4F662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9F44B1C-CB1C-A61C-E14A-550DB9E27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2E02BCC-9CF8-FBCE-8763-3146349EE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FD124CB-3BFC-6AEC-0D70-CB635B4EF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6976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D0DE5B-8770-41B0-5733-D9A9446D47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750BDD7-5C79-E27E-44DA-A58BA8FCD5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A926A3C-D177-B14E-1601-A65AAE17A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08B5D19-07E3-4618-FBDB-9A0A644D89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FC2D063-F409-F747-3CDE-9A2DC8C99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6823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C049FA1-7A42-7BCB-1CF3-DEC7910F4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413AA04-B0F1-4C10-2D39-7CA515DDF9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0A01598-1643-D635-A364-48708255E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C4FAE65-683F-788C-B6FE-3C84EBFCA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5D15FBC-26B0-96EA-6173-CAA392E2D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0638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5ED546-C678-DC20-FCE0-9185C50BD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006B409-8214-C218-9D50-B415A42B44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58EC3F8-5C5F-E2F7-2E5C-EB9AA74816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2ECA6FE-7BF5-A764-4D1E-4A7A230C1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341BB74-B692-4058-D986-12F270AF3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93D3F5A-EDB7-DD3D-40FA-C63501CA3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1369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F9F412-B709-ACF6-D0D7-99D5ECBFB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A8B7DC5-6BAC-D3A6-CDF1-37CEBFA710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7B58133-6328-A19A-B3D7-86FBAD0029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2878DB7-DA89-B6D0-8811-CD8D5B6686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E77B539-7EBD-3C7D-0BB2-9C86907274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4A88AB1-2F3B-497D-8878-ACE5CE88D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67D3C77-179A-E68F-9A7A-99ED66B70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BB5672C-08BD-A11F-5171-CA83A2AC4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3741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0D7BEC-DB17-C7BD-E795-A5E951F8A5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1349C1F-2711-74D2-B7AC-348D8AD3E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7EEEC91-3EF0-4800-8903-DC9EFD354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38BC87F-CAB0-F3BC-E413-25E4833CA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8220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22F3258-FFAD-3BCC-0F14-17DA36229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40AE7AC-ED82-C5A3-5F2C-C03B76D18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32B293D-B84A-0029-5771-095ABEA11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2779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DBF6259-E325-DE8C-AA3A-830BB7763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D9DA44C-9205-E504-2C30-AE31F15DBF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438C7F7-FEE4-5A35-BEEB-CB8CD3AC6C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F450CF5-1FC0-A45A-02C6-C60245B87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F0FAAC1-406C-066C-9490-213A39DE6B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12C9958-7545-484C-6416-B429C671B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8075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8733279-480D-B821-FF26-1FC64EBCD8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C862A3D-F038-AEE0-F017-B8E32A41DD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929DD44-4355-8367-4FDE-F4ADA8210F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3EF95E1-CEEF-7850-5155-95B93D800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98B226D-85A9-8040-FF86-72FF7C960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68FB276-C660-4968-B22A-9005F8752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2576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9D26397-4170-9D2A-62A8-12E1EE4F7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59DEFDB-CBC3-8554-7825-C77AC79572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287968A-40C4-F9C6-258F-22E4BD437F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7DCA1B-905D-C221-9CFE-888A9DCE36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630253F-9104-5AFD-0862-3E273FDAED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1060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id="{90A88A1C-41F6-9E83-4E3B-2E3728ECB8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2560" y="1112758"/>
            <a:ext cx="9393906" cy="4679676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71E62C83-A1E6-2D67-7F1F-9C22D701A4B1}"/>
              </a:ext>
            </a:extLst>
          </p:cNvPr>
          <p:cNvSpPr txBox="1"/>
          <p:nvPr/>
        </p:nvSpPr>
        <p:spPr>
          <a:xfrm>
            <a:off x="449679" y="400050"/>
            <a:ext cx="28886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92EA1D64-E281-4737-148D-B1C2BE821A81}"/>
              </a:ext>
            </a:extLst>
          </p:cNvPr>
          <p:cNvSpPr txBox="1"/>
          <p:nvPr/>
        </p:nvSpPr>
        <p:spPr>
          <a:xfrm>
            <a:off x="2701741" y="3362325"/>
            <a:ext cx="28886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hemoteherapy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alone 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ADB6F170-8E88-0C66-2AFE-6EF7B6DEA584}"/>
              </a:ext>
            </a:extLst>
          </p:cNvPr>
          <p:cNvSpPr txBox="1"/>
          <p:nvPr/>
        </p:nvSpPr>
        <p:spPr>
          <a:xfrm>
            <a:off x="2701741" y="3602304"/>
            <a:ext cx="28886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odality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treatment 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97CCEA0E-4415-8F9B-B6C7-92531D065B1D}"/>
              </a:ext>
            </a:extLst>
          </p:cNvPr>
          <p:cNvSpPr/>
          <p:nvPr/>
        </p:nvSpPr>
        <p:spPr>
          <a:xfrm>
            <a:off x="1789777" y="4841939"/>
            <a:ext cx="492795" cy="9504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153BBADB-C5E5-CAF1-343C-B3DCE8386857}"/>
              </a:ext>
            </a:extLst>
          </p:cNvPr>
          <p:cNvSpPr txBox="1"/>
          <p:nvPr/>
        </p:nvSpPr>
        <p:spPr>
          <a:xfrm>
            <a:off x="180242" y="5220151"/>
            <a:ext cx="2888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it-IT" sz="900" b="1" dirty="0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b="1" dirty="0" err="1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ality</a:t>
            </a:r>
            <a:r>
              <a:rPr lang="it-IT" sz="900" b="1" dirty="0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eatment </a:t>
            </a:r>
            <a:r>
              <a:rPr lang="it-IT" sz="900" b="1" dirty="0" err="1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900" b="1" dirty="0">
              <a:solidFill>
                <a:srgbClr val="3FCFD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0A14D3BE-0812-691C-3A1F-7A5E409D04A3}"/>
              </a:ext>
            </a:extLst>
          </p:cNvPr>
          <p:cNvSpPr txBox="1"/>
          <p:nvPr/>
        </p:nvSpPr>
        <p:spPr>
          <a:xfrm>
            <a:off x="180242" y="4842044"/>
            <a:ext cx="2888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>
                <a:solidFill>
                  <a:srgbClr val="F86F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emoteherapy</a:t>
            </a:r>
            <a:r>
              <a:rPr lang="it-IT" sz="900" b="1" dirty="0">
                <a:solidFill>
                  <a:srgbClr val="F86F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one </a:t>
            </a:r>
            <a:r>
              <a:rPr lang="it-IT" sz="900" b="1" dirty="0" err="1">
                <a:solidFill>
                  <a:srgbClr val="F86F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900" b="1" dirty="0">
              <a:solidFill>
                <a:srgbClr val="F86F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AB34C0F0-9191-8311-F934-93FD821EC289}"/>
              </a:ext>
            </a:extLst>
          </p:cNvPr>
          <p:cNvCxnSpPr>
            <a:cxnSpLocks/>
          </p:cNvCxnSpPr>
          <p:nvPr/>
        </p:nvCxnSpPr>
        <p:spPr>
          <a:xfrm>
            <a:off x="2478457" y="3493130"/>
            <a:ext cx="223284" cy="0"/>
          </a:xfrm>
          <a:prstGeom prst="line">
            <a:avLst/>
          </a:prstGeom>
          <a:ln>
            <a:solidFill>
              <a:srgbClr val="F86E64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diritto 9">
            <a:extLst>
              <a:ext uri="{FF2B5EF4-FFF2-40B4-BE49-F238E27FC236}">
                <a16:creationId xmlns:a16="http://schemas.microsoft.com/office/drawing/2014/main" id="{90F9A20C-AE91-6EAA-B12B-211D4F19C63A}"/>
              </a:ext>
            </a:extLst>
          </p:cNvPr>
          <p:cNvCxnSpPr>
            <a:cxnSpLocks/>
          </p:cNvCxnSpPr>
          <p:nvPr/>
        </p:nvCxnSpPr>
        <p:spPr>
          <a:xfrm>
            <a:off x="2483771" y="3733109"/>
            <a:ext cx="223284" cy="0"/>
          </a:xfrm>
          <a:prstGeom prst="line">
            <a:avLst/>
          </a:prstGeom>
          <a:ln>
            <a:solidFill>
              <a:srgbClr val="3FCFD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75092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NOVELLA PUGLIESE</dc:creator>
  <cp:lastModifiedBy>NOVELLA PUGLIESE</cp:lastModifiedBy>
  <cp:revision>5</cp:revision>
  <dcterms:created xsi:type="dcterms:W3CDTF">2024-04-12T14:35:17Z</dcterms:created>
  <dcterms:modified xsi:type="dcterms:W3CDTF">2024-04-14T18:11:01Z</dcterms:modified>
</cp:coreProperties>
</file>